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B1F70-A425-4E50-BC8D-6549C67001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FAA882-D3DF-46D6-90E2-B0CDEC2E65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D5656-302D-4B37-82C2-98A86A30F6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47994-BDC7-4A4C-B82F-71F95AA4EF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1CC44-4A64-425E-BFB6-BD87E93F0F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A7EECF-B88D-46E9-8C63-AD7F3C624A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D1685-C9C5-4C37-BC11-FD228B880D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CA8BD-BF60-41FD-9D0D-B57C3FF05D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552EF-099C-4410-8B10-16CDCFA612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F63DFB-9B4C-40D4-BB52-52D17DB572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FAC669-2A70-4CA1-888A-00055EFE97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8FE42-9E75-4D63-96AE-4FD3636DF5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21E0EB-12FB-4B94-BA62-59128166573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"/>
          <p:cNvGrpSpPr/>
          <p:nvPr/>
        </p:nvGrpSpPr>
        <p:grpSpPr>
          <a:xfrm>
            <a:off x="379440" y="1501920"/>
            <a:ext cx="8457120" cy="3003480"/>
            <a:chOff x="379440" y="1501920"/>
            <a:chExt cx="8457120" cy="3003480"/>
          </a:xfrm>
        </p:grpSpPr>
        <p:sp>
          <p:nvSpPr>
            <p:cNvPr id="42" name="Line 116"/>
            <p:cNvSpPr/>
            <p:nvPr/>
          </p:nvSpPr>
          <p:spPr>
            <a:xfrm flipV="1">
              <a:off x="1015920" y="4132080"/>
              <a:ext cx="6251400" cy="4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Freeform 447"/>
            <p:cNvSpPr/>
            <p:nvPr/>
          </p:nvSpPr>
          <p:spPr>
            <a:xfrm>
              <a:off x="1171800" y="4059000"/>
              <a:ext cx="387000" cy="146880"/>
            </a:xfrm>
            <a:custGeom>
              <a:avLst/>
              <a:gdLst>
                <a:gd name="textAreaLeft" fmla="*/ 0 w 387000"/>
                <a:gd name="textAreaRight" fmla="*/ 387360 w 38700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Freeform 447"/>
            <p:cNvSpPr/>
            <p:nvPr/>
          </p:nvSpPr>
          <p:spPr>
            <a:xfrm>
              <a:off x="6764760" y="4062600"/>
              <a:ext cx="358560" cy="146880"/>
            </a:xfrm>
            <a:custGeom>
              <a:avLst/>
              <a:gdLst>
                <a:gd name="textAreaLeft" fmla="*/ 0 w 358560"/>
                <a:gd name="textAreaRight" fmla="*/ 358920 w 35856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447"/>
            <p:cNvSpPr/>
            <p:nvPr/>
          </p:nvSpPr>
          <p:spPr>
            <a:xfrm>
              <a:off x="1567440" y="4063320"/>
              <a:ext cx="414000" cy="146880"/>
            </a:xfrm>
            <a:custGeom>
              <a:avLst/>
              <a:gdLst>
                <a:gd name="textAreaLeft" fmla="*/ 0 w 414000"/>
                <a:gd name="textAreaRight" fmla="*/ 414360 w 41400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Freeform 447"/>
            <p:cNvSpPr/>
            <p:nvPr/>
          </p:nvSpPr>
          <p:spPr>
            <a:xfrm>
              <a:off x="2000160" y="4062240"/>
              <a:ext cx="360720" cy="146880"/>
            </a:xfrm>
            <a:custGeom>
              <a:avLst/>
              <a:gdLst>
                <a:gd name="textAreaLeft" fmla="*/ 0 w 360720"/>
                <a:gd name="textAreaRight" fmla="*/ 361080 w 36072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447"/>
            <p:cNvSpPr/>
            <p:nvPr/>
          </p:nvSpPr>
          <p:spPr>
            <a:xfrm>
              <a:off x="2363760" y="4061520"/>
              <a:ext cx="266760" cy="146880"/>
            </a:xfrm>
            <a:custGeom>
              <a:avLst/>
              <a:gdLst>
                <a:gd name="textAreaLeft" fmla="*/ 0 w 266760"/>
                <a:gd name="textAreaRight" fmla="*/ 267120 w 26676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447"/>
            <p:cNvSpPr/>
            <p:nvPr/>
          </p:nvSpPr>
          <p:spPr>
            <a:xfrm>
              <a:off x="2632680" y="4060440"/>
              <a:ext cx="279000" cy="146880"/>
            </a:xfrm>
            <a:custGeom>
              <a:avLst/>
              <a:gdLst>
                <a:gd name="textAreaLeft" fmla="*/ 0 w 279000"/>
                <a:gd name="textAreaRight" fmla="*/ 279360 w 27900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447"/>
            <p:cNvSpPr/>
            <p:nvPr/>
          </p:nvSpPr>
          <p:spPr>
            <a:xfrm>
              <a:off x="2912040" y="4065120"/>
              <a:ext cx="401400" cy="146880"/>
            </a:xfrm>
            <a:custGeom>
              <a:avLst/>
              <a:gdLst>
                <a:gd name="textAreaLeft" fmla="*/ 0 w 401400"/>
                <a:gd name="textAreaRight" fmla="*/ 401760 w 40140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447"/>
            <p:cNvSpPr/>
            <p:nvPr/>
          </p:nvSpPr>
          <p:spPr>
            <a:xfrm>
              <a:off x="3312720" y="4064040"/>
              <a:ext cx="545040" cy="146880"/>
            </a:xfrm>
            <a:custGeom>
              <a:avLst/>
              <a:gdLst>
                <a:gd name="textAreaLeft" fmla="*/ 0 w 545040"/>
                <a:gd name="textAreaRight" fmla="*/ 545400 w 54504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447"/>
            <p:cNvSpPr/>
            <p:nvPr/>
          </p:nvSpPr>
          <p:spPr>
            <a:xfrm>
              <a:off x="3856320" y="4063320"/>
              <a:ext cx="393840" cy="146880"/>
            </a:xfrm>
            <a:custGeom>
              <a:avLst/>
              <a:gdLst>
                <a:gd name="textAreaLeft" fmla="*/ 0 w 393840"/>
                <a:gd name="textAreaRight" fmla="*/ 394200 w 39384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447"/>
            <p:cNvSpPr/>
            <p:nvPr/>
          </p:nvSpPr>
          <p:spPr>
            <a:xfrm>
              <a:off x="4246560" y="4062240"/>
              <a:ext cx="382680" cy="146880"/>
            </a:xfrm>
            <a:custGeom>
              <a:avLst/>
              <a:gdLst>
                <a:gd name="textAreaLeft" fmla="*/ 0 w 382680"/>
                <a:gd name="textAreaRight" fmla="*/ 383040 w 38268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447"/>
            <p:cNvSpPr/>
            <p:nvPr/>
          </p:nvSpPr>
          <p:spPr>
            <a:xfrm>
              <a:off x="4645440" y="4061520"/>
              <a:ext cx="435960" cy="146880"/>
            </a:xfrm>
            <a:custGeom>
              <a:avLst/>
              <a:gdLst>
                <a:gd name="textAreaLeft" fmla="*/ 0 w 435960"/>
                <a:gd name="textAreaRight" fmla="*/ 436320 w 43596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447"/>
            <p:cNvSpPr/>
            <p:nvPr/>
          </p:nvSpPr>
          <p:spPr>
            <a:xfrm>
              <a:off x="5295960" y="4064760"/>
              <a:ext cx="452880" cy="146880"/>
            </a:xfrm>
            <a:custGeom>
              <a:avLst/>
              <a:gdLst>
                <a:gd name="textAreaLeft" fmla="*/ 0 w 452880"/>
                <a:gd name="textAreaRight" fmla="*/ 453240 w 45288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447"/>
            <p:cNvSpPr/>
            <p:nvPr/>
          </p:nvSpPr>
          <p:spPr>
            <a:xfrm>
              <a:off x="5749560" y="4064040"/>
              <a:ext cx="369000" cy="146880"/>
            </a:xfrm>
            <a:custGeom>
              <a:avLst/>
              <a:gdLst>
                <a:gd name="textAreaLeft" fmla="*/ 0 w 369000"/>
                <a:gd name="textAreaRight" fmla="*/ 369360 w 36900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447"/>
            <p:cNvSpPr/>
            <p:nvPr/>
          </p:nvSpPr>
          <p:spPr>
            <a:xfrm>
              <a:off x="6129360" y="4062960"/>
              <a:ext cx="333720" cy="146880"/>
            </a:xfrm>
            <a:custGeom>
              <a:avLst/>
              <a:gdLst>
                <a:gd name="textAreaLeft" fmla="*/ 0 w 333720"/>
                <a:gd name="textAreaRight" fmla="*/ 334080 w 33372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447"/>
            <p:cNvSpPr/>
            <p:nvPr/>
          </p:nvSpPr>
          <p:spPr>
            <a:xfrm>
              <a:off x="6461280" y="4062240"/>
              <a:ext cx="303120" cy="146880"/>
            </a:xfrm>
            <a:custGeom>
              <a:avLst/>
              <a:gdLst>
                <a:gd name="textAreaLeft" fmla="*/ 0 w 303120"/>
                <a:gd name="textAreaRight" fmla="*/ 303480 w 30312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35"/>
            <p:cNvSpPr/>
            <p:nvPr/>
          </p:nvSpPr>
          <p:spPr>
            <a:xfrm>
              <a:off x="459720" y="4194720"/>
              <a:ext cx="123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MPREF0351_109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36"/>
            <p:cNvSpPr/>
            <p:nvPr/>
          </p:nvSpPr>
          <p:spPr>
            <a:xfrm>
              <a:off x="1518480" y="4194720"/>
              <a:ext cx="58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37"/>
            <p:cNvSpPr/>
            <p:nvPr/>
          </p:nvSpPr>
          <p:spPr>
            <a:xfrm>
              <a:off x="1933920" y="4194720"/>
              <a:ext cx="58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38"/>
            <p:cNvSpPr/>
            <p:nvPr/>
          </p:nvSpPr>
          <p:spPr>
            <a:xfrm>
              <a:off x="2254680" y="4289760"/>
              <a:ext cx="58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39"/>
            <p:cNvSpPr/>
            <p:nvPr/>
          </p:nvSpPr>
          <p:spPr>
            <a:xfrm>
              <a:off x="2516760" y="4194720"/>
              <a:ext cx="58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40"/>
            <p:cNvSpPr/>
            <p:nvPr/>
          </p:nvSpPr>
          <p:spPr>
            <a:xfrm>
              <a:off x="2852280" y="4194720"/>
              <a:ext cx="58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41"/>
            <p:cNvSpPr/>
            <p:nvPr/>
          </p:nvSpPr>
          <p:spPr>
            <a:xfrm>
              <a:off x="3304440" y="4194720"/>
              <a:ext cx="584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42"/>
            <p:cNvSpPr/>
            <p:nvPr/>
          </p:nvSpPr>
          <p:spPr>
            <a:xfrm>
              <a:off x="3808080" y="4194720"/>
              <a:ext cx="50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43"/>
            <p:cNvSpPr/>
            <p:nvPr/>
          </p:nvSpPr>
          <p:spPr>
            <a:xfrm>
              <a:off x="4187160" y="4194720"/>
              <a:ext cx="50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44"/>
            <p:cNvSpPr/>
            <p:nvPr/>
          </p:nvSpPr>
          <p:spPr>
            <a:xfrm>
              <a:off x="4610160" y="4194720"/>
              <a:ext cx="50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45"/>
            <p:cNvSpPr/>
            <p:nvPr/>
          </p:nvSpPr>
          <p:spPr>
            <a:xfrm>
              <a:off x="4938120" y="4194720"/>
              <a:ext cx="50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46"/>
            <p:cNvSpPr/>
            <p:nvPr/>
          </p:nvSpPr>
          <p:spPr>
            <a:xfrm>
              <a:off x="5280840" y="4194720"/>
              <a:ext cx="50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47"/>
            <p:cNvSpPr/>
            <p:nvPr/>
          </p:nvSpPr>
          <p:spPr>
            <a:xfrm>
              <a:off x="5681880" y="4194720"/>
              <a:ext cx="50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49"/>
            <p:cNvSpPr/>
            <p:nvPr/>
          </p:nvSpPr>
          <p:spPr>
            <a:xfrm>
              <a:off x="6031800" y="4194720"/>
              <a:ext cx="50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50"/>
            <p:cNvSpPr/>
            <p:nvPr/>
          </p:nvSpPr>
          <p:spPr>
            <a:xfrm>
              <a:off x="6359760" y="4194720"/>
              <a:ext cx="50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51"/>
            <p:cNvSpPr/>
            <p:nvPr/>
          </p:nvSpPr>
          <p:spPr>
            <a:xfrm>
              <a:off x="6702480" y="4194720"/>
              <a:ext cx="506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092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116"/>
            <p:cNvSpPr/>
            <p:nvPr/>
          </p:nvSpPr>
          <p:spPr>
            <a:xfrm>
              <a:off x="1011240" y="3702240"/>
              <a:ext cx="4405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447"/>
            <p:cNvSpPr/>
            <p:nvPr/>
          </p:nvSpPr>
          <p:spPr>
            <a:xfrm>
              <a:off x="5069520" y="4060440"/>
              <a:ext cx="241200" cy="14688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70c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447"/>
            <p:cNvSpPr/>
            <p:nvPr/>
          </p:nvSpPr>
          <p:spPr>
            <a:xfrm>
              <a:off x="1171440" y="3627720"/>
              <a:ext cx="311040" cy="145800"/>
            </a:xfrm>
            <a:custGeom>
              <a:avLst/>
              <a:gdLst>
                <a:gd name="textAreaLeft" fmla="*/ 0 w 311040"/>
                <a:gd name="textAreaRight" fmla="*/ 311400 w 311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447"/>
            <p:cNvSpPr/>
            <p:nvPr/>
          </p:nvSpPr>
          <p:spPr>
            <a:xfrm>
              <a:off x="4914720" y="3629160"/>
              <a:ext cx="350640" cy="145800"/>
            </a:xfrm>
            <a:custGeom>
              <a:avLst/>
              <a:gdLst>
                <a:gd name="textAreaLeft" fmla="*/ 0 w 350640"/>
                <a:gd name="textAreaRight" fmla="*/ 351000 w 3506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55"/>
            <p:cNvSpPr/>
            <p:nvPr/>
          </p:nvSpPr>
          <p:spPr>
            <a:xfrm>
              <a:off x="379440" y="3746880"/>
              <a:ext cx="11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MPREF9522_025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1"/>
            <p:cNvSpPr/>
            <p:nvPr/>
          </p:nvSpPr>
          <p:spPr>
            <a:xfrm>
              <a:off x="7212600" y="4005000"/>
              <a:ext cx="16239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TX1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; 1,230,933; 1,231,502;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Calibri"/>
                </a:rPr>
                <a:t>E980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; 1,231,410; U0137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47"/>
            <p:cNvSpPr/>
            <p:nvPr/>
          </p:nvSpPr>
          <p:spPr>
            <a:xfrm>
              <a:off x="1495440" y="3627720"/>
              <a:ext cx="333360" cy="145800"/>
            </a:xfrm>
            <a:custGeom>
              <a:avLst/>
              <a:gdLst>
                <a:gd name="textAreaLeft" fmla="*/ 0 w 333360"/>
                <a:gd name="textAreaRight" fmla="*/ 333720 w 33336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57"/>
            <p:cNvSpPr/>
            <p:nvPr/>
          </p:nvSpPr>
          <p:spPr>
            <a:xfrm>
              <a:off x="1419480" y="3746880"/>
              <a:ext cx="479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25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47"/>
            <p:cNvSpPr/>
            <p:nvPr/>
          </p:nvSpPr>
          <p:spPr>
            <a:xfrm>
              <a:off x="1831680" y="3627720"/>
              <a:ext cx="271440" cy="145800"/>
            </a:xfrm>
            <a:custGeom>
              <a:avLst/>
              <a:gdLst>
                <a:gd name="textAreaLeft" fmla="*/ 0 w 271440"/>
                <a:gd name="textAreaRight" fmla="*/ 271800 w 2714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447"/>
            <p:cNvSpPr/>
            <p:nvPr/>
          </p:nvSpPr>
          <p:spPr>
            <a:xfrm>
              <a:off x="2104920" y="3627720"/>
              <a:ext cx="412560" cy="145800"/>
            </a:xfrm>
            <a:custGeom>
              <a:avLst/>
              <a:gdLst>
                <a:gd name="textAreaLeft" fmla="*/ 0 w 412560"/>
                <a:gd name="textAreaRight" fmla="*/ 412920 w 41256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60"/>
            <p:cNvSpPr/>
            <p:nvPr/>
          </p:nvSpPr>
          <p:spPr>
            <a:xfrm>
              <a:off x="1735200" y="3746880"/>
              <a:ext cx="479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25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61"/>
            <p:cNvSpPr/>
            <p:nvPr/>
          </p:nvSpPr>
          <p:spPr>
            <a:xfrm>
              <a:off x="2063520" y="374688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25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447"/>
            <p:cNvSpPr/>
            <p:nvPr/>
          </p:nvSpPr>
          <p:spPr>
            <a:xfrm>
              <a:off x="2512800" y="3627720"/>
              <a:ext cx="382320" cy="145800"/>
            </a:xfrm>
            <a:custGeom>
              <a:avLst/>
              <a:gdLst>
                <a:gd name="textAreaLeft" fmla="*/ 0 w 382320"/>
                <a:gd name="textAreaRight" fmla="*/ 382680 w 38232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63"/>
            <p:cNvSpPr/>
            <p:nvPr/>
          </p:nvSpPr>
          <p:spPr>
            <a:xfrm>
              <a:off x="2455200" y="374688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25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447"/>
            <p:cNvSpPr/>
            <p:nvPr/>
          </p:nvSpPr>
          <p:spPr>
            <a:xfrm>
              <a:off x="2904840" y="3627720"/>
              <a:ext cx="382320" cy="145800"/>
            </a:xfrm>
            <a:custGeom>
              <a:avLst/>
              <a:gdLst>
                <a:gd name="textAreaLeft" fmla="*/ 0 w 382320"/>
                <a:gd name="textAreaRight" fmla="*/ 382680 w 38232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65"/>
            <p:cNvSpPr/>
            <p:nvPr/>
          </p:nvSpPr>
          <p:spPr>
            <a:xfrm>
              <a:off x="2840040" y="374688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25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447"/>
            <p:cNvSpPr/>
            <p:nvPr/>
          </p:nvSpPr>
          <p:spPr>
            <a:xfrm>
              <a:off x="3313080" y="3627720"/>
              <a:ext cx="588960" cy="145800"/>
            </a:xfrm>
            <a:custGeom>
              <a:avLst/>
              <a:gdLst>
                <a:gd name="textAreaLeft" fmla="*/ 0 w 588960"/>
                <a:gd name="textAreaRight" fmla="*/ 589320 w 58896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67"/>
            <p:cNvSpPr/>
            <p:nvPr/>
          </p:nvSpPr>
          <p:spPr>
            <a:xfrm>
              <a:off x="3359520" y="374688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250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447"/>
            <p:cNvSpPr/>
            <p:nvPr/>
          </p:nvSpPr>
          <p:spPr>
            <a:xfrm>
              <a:off x="3922560" y="3627720"/>
              <a:ext cx="428400" cy="145800"/>
            </a:xfrm>
            <a:custGeom>
              <a:avLst/>
              <a:gdLst>
                <a:gd name="textAreaLeft" fmla="*/ 0 w 428400"/>
                <a:gd name="textAreaRight" fmla="*/ 428760 w 42840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69"/>
            <p:cNvSpPr/>
            <p:nvPr/>
          </p:nvSpPr>
          <p:spPr>
            <a:xfrm>
              <a:off x="3892320" y="374688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25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447"/>
            <p:cNvSpPr/>
            <p:nvPr/>
          </p:nvSpPr>
          <p:spPr>
            <a:xfrm>
              <a:off x="4344840" y="3627720"/>
              <a:ext cx="558720" cy="145800"/>
            </a:xfrm>
            <a:custGeom>
              <a:avLst/>
              <a:gdLst>
                <a:gd name="textAreaLeft" fmla="*/ 0 w 558720"/>
                <a:gd name="textAreaRight" fmla="*/ 559080 w 55872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71"/>
            <p:cNvSpPr/>
            <p:nvPr/>
          </p:nvSpPr>
          <p:spPr>
            <a:xfrm>
              <a:off x="4398840" y="374688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25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72"/>
            <p:cNvSpPr/>
            <p:nvPr/>
          </p:nvSpPr>
          <p:spPr>
            <a:xfrm>
              <a:off x="4866480" y="374688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25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73"/>
            <p:cNvSpPr/>
            <p:nvPr/>
          </p:nvSpPr>
          <p:spPr>
            <a:xfrm>
              <a:off x="5371200" y="3571920"/>
              <a:ext cx="271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TX82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; TX0133A; 1,231,408; C68; D344SRF; E1162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116"/>
            <p:cNvSpPr/>
            <p:nvPr/>
          </p:nvSpPr>
          <p:spPr>
            <a:xfrm>
              <a:off x="1012680" y="3105360"/>
              <a:ext cx="4405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447"/>
            <p:cNvSpPr/>
            <p:nvPr/>
          </p:nvSpPr>
          <p:spPr>
            <a:xfrm>
              <a:off x="1171440" y="3030480"/>
              <a:ext cx="404640" cy="147600"/>
            </a:xfrm>
            <a:custGeom>
              <a:avLst/>
              <a:gdLst>
                <a:gd name="textAreaLeft" fmla="*/ 0 w 404640"/>
                <a:gd name="textAreaRight" fmla="*/ 405000 w 4046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447"/>
            <p:cNvSpPr/>
            <p:nvPr/>
          </p:nvSpPr>
          <p:spPr>
            <a:xfrm>
              <a:off x="4857480" y="3033720"/>
              <a:ext cx="365040" cy="145800"/>
            </a:xfrm>
            <a:custGeom>
              <a:avLst/>
              <a:gdLst>
                <a:gd name="textAreaLeft" fmla="*/ 0 w 365040"/>
                <a:gd name="textAreaRight" fmla="*/ 365400 w 365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447"/>
            <p:cNvSpPr/>
            <p:nvPr/>
          </p:nvSpPr>
          <p:spPr>
            <a:xfrm>
              <a:off x="1612800" y="3035520"/>
              <a:ext cx="361800" cy="145800"/>
            </a:xfrm>
            <a:custGeom>
              <a:avLst/>
              <a:gdLst>
                <a:gd name="textAreaLeft" fmla="*/ 0 w 361800"/>
                <a:gd name="textAreaRight" fmla="*/ 362160 w 36180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78"/>
            <p:cNvSpPr/>
            <p:nvPr/>
          </p:nvSpPr>
          <p:spPr>
            <a:xfrm>
              <a:off x="534960" y="3136320"/>
              <a:ext cx="116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MPREF0352_044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79"/>
            <p:cNvSpPr/>
            <p:nvPr/>
          </p:nvSpPr>
          <p:spPr>
            <a:xfrm>
              <a:off x="1578960" y="3136320"/>
              <a:ext cx="479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4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447"/>
            <p:cNvSpPr/>
            <p:nvPr/>
          </p:nvSpPr>
          <p:spPr>
            <a:xfrm>
              <a:off x="1968480" y="3033720"/>
              <a:ext cx="282240" cy="147600"/>
            </a:xfrm>
            <a:custGeom>
              <a:avLst/>
              <a:gdLst>
                <a:gd name="textAreaLeft" fmla="*/ 0 w 282240"/>
                <a:gd name="textAreaRight" fmla="*/ 282600 w 2822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81"/>
            <p:cNvSpPr/>
            <p:nvPr/>
          </p:nvSpPr>
          <p:spPr>
            <a:xfrm>
              <a:off x="1899360" y="3136320"/>
              <a:ext cx="42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4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447"/>
            <p:cNvSpPr/>
            <p:nvPr/>
          </p:nvSpPr>
          <p:spPr>
            <a:xfrm>
              <a:off x="2239920" y="3033720"/>
              <a:ext cx="420480" cy="145800"/>
            </a:xfrm>
            <a:custGeom>
              <a:avLst/>
              <a:gdLst>
                <a:gd name="textAreaLeft" fmla="*/ 0 w 420480"/>
                <a:gd name="textAreaRight" fmla="*/ 420840 w 42048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Box 83"/>
            <p:cNvSpPr/>
            <p:nvPr/>
          </p:nvSpPr>
          <p:spPr>
            <a:xfrm>
              <a:off x="2228040" y="3136320"/>
              <a:ext cx="42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45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447"/>
            <p:cNvSpPr/>
            <p:nvPr/>
          </p:nvSpPr>
          <p:spPr>
            <a:xfrm>
              <a:off x="2657520" y="3036960"/>
              <a:ext cx="368280" cy="145800"/>
            </a:xfrm>
            <a:custGeom>
              <a:avLst/>
              <a:gdLst>
                <a:gd name="textAreaLeft" fmla="*/ 0 w 368280"/>
                <a:gd name="textAreaRight" fmla="*/ 368640 w 36828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86"/>
            <p:cNvSpPr/>
            <p:nvPr/>
          </p:nvSpPr>
          <p:spPr>
            <a:xfrm>
              <a:off x="2624040" y="3136320"/>
              <a:ext cx="42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45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447"/>
            <p:cNvSpPr/>
            <p:nvPr/>
          </p:nvSpPr>
          <p:spPr>
            <a:xfrm>
              <a:off x="3033720" y="3035520"/>
              <a:ext cx="529920" cy="147600"/>
            </a:xfrm>
            <a:custGeom>
              <a:avLst/>
              <a:gdLst>
                <a:gd name="textAreaLeft" fmla="*/ 0 w 529920"/>
                <a:gd name="textAreaRight" fmla="*/ 530280 w 52992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e46c0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Box 88"/>
            <p:cNvSpPr/>
            <p:nvPr/>
          </p:nvSpPr>
          <p:spPr>
            <a:xfrm>
              <a:off x="3060720" y="3136320"/>
              <a:ext cx="42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4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447"/>
            <p:cNvSpPr/>
            <p:nvPr/>
          </p:nvSpPr>
          <p:spPr>
            <a:xfrm>
              <a:off x="3566880" y="3035520"/>
              <a:ext cx="311040" cy="147600"/>
            </a:xfrm>
            <a:custGeom>
              <a:avLst/>
              <a:gdLst>
                <a:gd name="textAreaLeft" fmla="*/ 0 w 311040"/>
                <a:gd name="textAreaRight" fmla="*/ 311400 w 3110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e46c0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90"/>
            <p:cNvSpPr/>
            <p:nvPr/>
          </p:nvSpPr>
          <p:spPr>
            <a:xfrm>
              <a:off x="3502080" y="3136320"/>
              <a:ext cx="42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45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91"/>
            <p:cNvSpPr/>
            <p:nvPr/>
          </p:nvSpPr>
          <p:spPr>
            <a:xfrm>
              <a:off x="3871800" y="3136320"/>
              <a:ext cx="42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4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447"/>
            <p:cNvSpPr/>
            <p:nvPr/>
          </p:nvSpPr>
          <p:spPr>
            <a:xfrm>
              <a:off x="3902040" y="3038760"/>
              <a:ext cx="361800" cy="147600"/>
            </a:xfrm>
            <a:custGeom>
              <a:avLst/>
              <a:gdLst>
                <a:gd name="textAreaLeft" fmla="*/ 0 w 361800"/>
                <a:gd name="textAreaRight" fmla="*/ 362160 w 36180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e46c0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Box 93"/>
            <p:cNvSpPr/>
            <p:nvPr/>
          </p:nvSpPr>
          <p:spPr>
            <a:xfrm>
              <a:off x="4328280" y="3136320"/>
              <a:ext cx="42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45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Box 94"/>
            <p:cNvSpPr/>
            <p:nvPr/>
          </p:nvSpPr>
          <p:spPr>
            <a:xfrm>
              <a:off x="4831200" y="3136320"/>
              <a:ext cx="42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45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447"/>
            <p:cNvSpPr/>
            <p:nvPr/>
          </p:nvSpPr>
          <p:spPr>
            <a:xfrm>
              <a:off x="4281480" y="3038760"/>
              <a:ext cx="541080" cy="145800"/>
            </a:xfrm>
            <a:custGeom>
              <a:avLst/>
              <a:gdLst>
                <a:gd name="textAreaLeft" fmla="*/ 0 w 541080"/>
                <a:gd name="textAreaRight" fmla="*/ 541440 w 54108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e46c0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447"/>
            <p:cNvSpPr/>
            <p:nvPr/>
          </p:nvSpPr>
          <p:spPr>
            <a:xfrm>
              <a:off x="3033720" y="2870280"/>
              <a:ext cx="529920" cy="145800"/>
            </a:xfrm>
            <a:custGeom>
              <a:avLst/>
              <a:gdLst>
                <a:gd name="textAreaLeft" fmla="*/ 0 w 529920"/>
                <a:gd name="textAreaRight" fmla="*/ 530280 w 52992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ac09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447"/>
            <p:cNvSpPr/>
            <p:nvPr/>
          </p:nvSpPr>
          <p:spPr>
            <a:xfrm>
              <a:off x="3565440" y="2865600"/>
              <a:ext cx="312480" cy="145800"/>
            </a:xfrm>
            <a:custGeom>
              <a:avLst/>
              <a:gdLst>
                <a:gd name="textAreaLeft" fmla="*/ 0 w 312480"/>
                <a:gd name="textAreaRight" fmla="*/ 312840 w 31248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ac09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447"/>
            <p:cNvSpPr/>
            <p:nvPr/>
          </p:nvSpPr>
          <p:spPr>
            <a:xfrm>
              <a:off x="3900600" y="2690280"/>
              <a:ext cx="362880" cy="146880"/>
            </a:xfrm>
            <a:custGeom>
              <a:avLst/>
              <a:gdLst>
                <a:gd name="textAreaLeft" fmla="*/ 0 w 362880"/>
                <a:gd name="textAreaRight" fmla="*/ 363240 w 36288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447"/>
            <p:cNvSpPr/>
            <p:nvPr/>
          </p:nvSpPr>
          <p:spPr>
            <a:xfrm>
              <a:off x="3031920" y="2698920"/>
              <a:ext cx="529920" cy="147600"/>
            </a:xfrm>
            <a:custGeom>
              <a:avLst/>
              <a:gdLst>
                <a:gd name="textAreaLeft" fmla="*/ 0 w 529920"/>
                <a:gd name="textAreaRight" fmla="*/ 530280 w 52992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ac09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447"/>
            <p:cNvSpPr/>
            <p:nvPr/>
          </p:nvSpPr>
          <p:spPr>
            <a:xfrm>
              <a:off x="3565440" y="2694240"/>
              <a:ext cx="312480" cy="147600"/>
            </a:xfrm>
            <a:custGeom>
              <a:avLst/>
              <a:gdLst>
                <a:gd name="textAreaLeft" fmla="*/ 0 w 312480"/>
                <a:gd name="textAreaRight" fmla="*/ 312840 w 3124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ac09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Box 101"/>
            <p:cNvSpPr/>
            <p:nvPr/>
          </p:nvSpPr>
          <p:spPr>
            <a:xfrm>
              <a:off x="5342040" y="2981160"/>
              <a:ext cx="994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TX1330</a:t>
              </a:r>
              <a:r>
                <a:rPr b="0" lang="en-US" sz="1000" spc="-1" strike="noStrike">
                  <a:solidFill>
                    <a:srgbClr val="ff0000"/>
                  </a:solidFill>
                  <a:latin typeface="Calibri"/>
                </a:rPr>
                <a:t>; Com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Box 102"/>
            <p:cNvSpPr/>
            <p:nvPr/>
          </p:nvSpPr>
          <p:spPr>
            <a:xfrm>
              <a:off x="5347440" y="2811600"/>
              <a:ext cx="69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Calibri"/>
                </a:rPr>
                <a:t>1,141,73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Box 103"/>
            <p:cNvSpPr/>
            <p:nvPr/>
          </p:nvSpPr>
          <p:spPr>
            <a:xfrm>
              <a:off x="5344920" y="2627640"/>
              <a:ext cx="69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,231,5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447"/>
            <p:cNvSpPr/>
            <p:nvPr/>
          </p:nvSpPr>
          <p:spPr>
            <a:xfrm>
              <a:off x="1170000" y="2862360"/>
              <a:ext cx="406080" cy="145800"/>
            </a:xfrm>
            <a:custGeom>
              <a:avLst/>
              <a:gdLst>
                <a:gd name="textAreaLeft" fmla="*/ 0 w 406080"/>
                <a:gd name="textAreaRight" fmla="*/ 406440 w 40608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447"/>
            <p:cNvSpPr/>
            <p:nvPr/>
          </p:nvSpPr>
          <p:spPr>
            <a:xfrm>
              <a:off x="1611000" y="2865600"/>
              <a:ext cx="363240" cy="145800"/>
            </a:xfrm>
            <a:custGeom>
              <a:avLst/>
              <a:gdLst>
                <a:gd name="textAreaLeft" fmla="*/ 0 w 363240"/>
                <a:gd name="textAreaRight" fmla="*/ 363600 w 3632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447"/>
            <p:cNvSpPr/>
            <p:nvPr/>
          </p:nvSpPr>
          <p:spPr>
            <a:xfrm>
              <a:off x="1966680" y="2863800"/>
              <a:ext cx="284040" cy="147600"/>
            </a:xfrm>
            <a:custGeom>
              <a:avLst/>
              <a:gdLst>
                <a:gd name="textAreaLeft" fmla="*/ 0 w 284040"/>
                <a:gd name="textAreaRight" fmla="*/ 284400 w 2840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447"/>
            <p:cNvSpPr/>
            <p:nvPr/>
          </p:nvSpPr>
          <p:spPr>
            <a:xfrm>
              <a:off x="2239920" y="2863800"/>
              <a:ext cx="420480" cy="147600"/>
            </a:xfrm>
            <a:custGeom>
              <a:avLst/>
              <a:gdLst>
                <a:gd name="textAreaLeft" fmla="*/ 0 w 420480"/>
                <a:gd name="textAreaRight" fmla="*/ 420840 w 4204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447"/>
            <p:cNvSpPr/>
            <p:nvPr/>
          </p:nvSpPr>
          <p:spPr>
            <a:xfrm>
              <a:off x="2657520" y="2867040"/>
              <a:ext cx="368280" cy="147600"/>
            </a:xfrm>
            <a:custGeom>
              <a:avLst/>
              <a:gdLst>
                <a:gd name="textAreaLeft" fmla="*/ 0 w 368280"/>
                <a:gd name="textAreaRight" fmla="*/ 368640 w 3682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447"/>
            <p:cNvSpPr/>
            <p:nvPr/>
          </p:nvSpPr>
          <p:spPr>
            <a:xfrm>
              <a:off x="1176120" y="2692440"/>
              <a:ext cx="404640" cy="145800"/>
            </a:xfrm>
            <a:custGeom>
              <a:avLst/>
              <a:gdLst>
                <a:gd name="textAreaLeft" fmla="*/ 0 w 404640"/>
                <a:gd name="textAreaRight" fmla="*/ 405000 w 4046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447"/>
            <p:cNvSpPr/>
            <p:nvPr/>
          </p:nvSpPr>
          <p:spPr>
            <a:xfrm>
              <a:off x="1617480" y="2695680"/>
              <a:ext cx="361800" cy="147600"/>
            </a:xfrm>
            <a:custGeom>
              <a:avLst/>
              <a:gdLst>
                <a:gd name="textAreaLeft" fmla="*/ 0 w 361800"/>
                <a:gd name="textAreaRight" fmla="*/ 362160 w 36180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447"/>
            <p:cNvSpPr/>
            <p:nvPr/>
          </p:nvSpPr>
          <p:spPr>
            <a:xfrm>
              <a:off x="1973160" y="2695680"/>
              <a:ext cx="282240" cy="145800"/>
            </a:xfrm>
            <a:custGeom>
              <a:avLst/>
              <a:gdLst>
                <a:gd name="textAreaLeft" fmla="*/ 0 w 282240"/>
                <a:gd name="textAreaRight" fmla="*/ 282600 w 2822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447"/>
            <p:cNvSpPr/>
            <p:nvPr/>
          </p:nvSpPr>
          <p:spPr>
            <a:xfrm>
              <a:off x="2246040" y="2694240"/>
              <a:ext cx="419040" cy="147600"/>
            </a:xfrm>
            <a:custGeom>
              <a:avLst/>
              <a:gdLst>
                <a:gd name="textAreaLeft" fmla="*/ 0 w 419040"/>
                <a:gd name="textAreaRight" fmla="*/ 419400 w 4190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447"/>
            <p:cNvSpPr/>
            <p:nvPr/>
          </p:nvSpPr>
          <p:spPr>
            <a:xfrm>
              <a:off x="2662200" y="2697120"/>
              <a:ext cx="368280" cy="147600"/>
            </a:xfrm>
            <a:custGeom>
              <a:avLst/>
              <a:gdLst>
                <a:gd name="textAreaLeft" fmla="*/ 0 w 368280"/>
                <a:gd name="textAreaRight" fmla="*/ 368640 w 3682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447"/>
            <p:cNvSpPr/>
            <p:nvPr/>
          </p:nvSpPr>
          <p:spPr>
            <a:xfrm>
              <a:off x="4856040" y="2871720"/>
              <a:ext cx="365040" cy="145800"/>
            </a:xfrm>
            <a:custGeom>
              <a:avLst/>
              <a:gdLst>
                <a:gd name="textAreaLeft" fmla="*/ 0 w 365040"/>
                <a:gd name="textAreaRight" fmla="*/ 365400 w 365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Freeform 447"/>
            <p:cNvSpPr/>
            <p:nvPr/>
          </p:nvSpPr>
          <p:spPr>
            <a:xfrm>
              <a:off x="3900240" y="2876760"/>
              <a:ext cx="363240" cy="147600"/>
            </a:xfrm>
            <a:custGeom>
              <a:avLst/>
              <a:gdLst>
                <a:gd name="textAreaLeft" fmla="*/ 0 w 363240"/>
                <a:gd name="textAreaRight" fmla="*/ 363600 w 3632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e46c0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447"/>
            <p:cNvSpPr/>
            <p:nvPr/>
          </p:nvSpPr>
          <p:spPr>
            <a:xfrm>
              <a:off x="4279680" y="2874960"/>
              <a:ext cx="541080" cy="147600"/>
            </a:xfrm>
            <a:custGeom>
              <a:avLst/>
              <a:gdLst>
                <a:gd name="textAreaLeft" fmla="*/ 0 w 541080"/>
                <a:gd name="textAreaRight" fmla="*/ 541440 w 5410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e46c0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447"/>
            <p:cNvSpPr/>
            <p:nvPr/>
          </p:nvSpPr>
          <p:spPr>
            <a:xfrm>
              <a:off x="4856040" y="2694240"/>
              <a:ext cx="363240" cy="147600"/>
            </a:xfrm>
            <a:custGeom>
              <a:avLst/>
              <a:gdLst>
                <a:gd name="textAreaLeft" fmla="*/ 0 w 363240"/>
                <a:gd name="textAreaRight" fmla="*/ 363600 w 3632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447"/>
            <p:cNvSpPr/>
            <p:nvPr/>
          </p:nvSpPr>
          <p:spPr>
            <a:xfrm>
              <a:off x="4278240" y="2698920"/>
              <a:ext cx="542880" cy="147600"/>
            </a:xfrm>
            <a:custGeom>
              <a:avLst/>
              <a:gdLst>
                <a:gd name="textAreaLeft" fmla="*/ 0 w 542880"/>
                <a:gd name="textAreaRight" fmla="*/ 543240 w 5428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e46c0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447"/>
            <p:cNvSpPr/>
            <p:nvPr/>
          </p:nvSpPr>
          <p:spPr>
            <a:xfrm>
              <a:off x="3899520" y="2506320"/>
              <a:ext cx="362880" cy="146880"/>
            </a:xfrm>
            <a:custGeom>
              <a:avLst/>
              <a:gdLst>
                <a:gd name="textAreaLeft" fmla="*/ 0 w 362880"/>
                <a:gd name="textAreaRight" fmla="*/ 363240 w 36288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447"/>
            <p:cNvSpPr/>
            <p:nvPr/>
          </p:nvSpPr>
          <p:spPr>
            <a:xfrm>
              <a:off x="3030480" y="2514600"/>
              <a:ext cx="531720" cy="147600"/>
            </a:xfrm>
            <a:custGeom>
              <a:avLst/>
              <a:gdLst>
                <a:gd name="textAreaLeft" fmla="*/ 0 w 531720"/>
                <a:gd name="textAreaRight" fmla="*/ 532080 w 53172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ac09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447"/>
            <p:cNvSpPr/>
            <p:nvPr/>
          </p:nvSpPr>
          <p:spPr>
            <a:xfrm>
              <a:off x="3564000" y="2509920"/>
              <a:ext cx="312480" cy="147600"/>
            </a:xfrm>
            <a:custGeom>
              <a:avLst/>
              <a:gdLst>
                <a:gd name="textAreaLeft" fmla="*/ 0 w 312480"/>
                <a:gd name="textAreaRight" fmla="*/ 312840 w 3124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ac09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447"/>
            <p:cNvSpPr/>
            <p:nvPr/>
          </p:nvSpPr>
          <p:spPr>
            <a:xfrm>
              <a:off x="1174680" y="2508480"/>
              <a:ext cx="406080" cy="147600"/>
            </a:xfrm>
            <a:custGeom>
              <a:avLst/>
              <a:gdLst>
                <a:gd name="textAreaLeft" fmla="*/ 0 w 406080"/>
                <a:gd name="textAreaRight" fmla="*/ 406440 w 4060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447"/>
            <p:cNvSpPr/>
            <p:nvPr/>
          </p:nvSpPr>
          <p:spPr>
            <a:xfrm>
              <a:off x="1616040" y="2511360"/>
              <a:ext cx="363240" cy="147600"/>
            </a:xfrm>
            <a:custGeom>
              <a:avLst/>
              <a:gdLst>
                <a:gd name="textAreaLeft" fmla="*/ 0 w 363240"/>
                <a:gd name="textAreaRight" fmla="*/ 363600 w 3632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447"/>
            <p:cNvSpPr/>
            <p:nvPr/>
          </p:nvSpPr>
          <p:spPr>
            <a:xfrm>
              <a:off x="1971720" y="2511360"/>
              <a:ext cx="284040" cy="145800"/>
            </a:xfrm>
            <a:custGeom>
              <a:avLst/>
              <a:gdLst>
                <a:gd name="textAreaLeft" fmla="*/ 0 w 284040"/>
                <a:gd name="textAreaRight" fmla="*/ 284400 w 284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447"/>
            <p:cNvSpPr/>
            <p:nvPr/>
          </p:nvSpPr>
          <p:spPr>
            <a:xfrm>
              <a:off x="2244600" y="2509920"/>
              <a:ext cx="420480" cy="147600"/>
            </a:xfrm>
            <a:custGeom>
              <a:avLst/>
              <a:gdLst>
                <a:gd name="textAreaLeft" fmla="*/ 0 w 420480"/>
                <a:gd name="textAreaRight" fmla="*/ 420840 w 4204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604a7b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447"/>
            <p:cNvSpPr/>
            <p:nvPr/>
          </p:nvSpPr>
          <p:spPr>
            <a:xfrm>
              <a:off x="2662200" y="2513160"/>
              <a:ext cx="368280" cy="147600"/>
            </a:xfrm>
            <a:custGeom>
              <a:avLst/>
              <a:gdLst>
                <a:gd name="textAreaLeft" fmla="*/ 0 w 368280"/>
                <a:gd name="textAreaRight" fmla="*/ 368640 w 3682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447"/>
            <p:cNvSpPr/>
            <p:nvPr/>
          </p:nvSpPr>
          <p:spPr>
            <a:xfrm>
              <a:off x="4854600" y="2509920"/>
              <a:ext cx="365040" cy="147600"/>
            </a:xfrm>
            <a:custGeom>
              <a:avLst/>
              <a:gdLst>
                <a:gd name="textAreaLeft" fmla="*/ 0 w 365040"/>
                <a:gd name="textAreaRight" fmla="*/ 365400 w 3650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447"/>
            <p:cNvSpPr/>
            <p:nvPr/>
          </p:nvSpPr>
          <p:spPr>
            <a:xfrm>
              <a:off x="4278240" y="2514600"/>
              <a:ext cx="541080" cy="147600"/>
            </a:xfrm>
            <a:custGeom>
              <a:avLst/>
              <a:gdLst>
                <a:gd name="textAreaLeft" fmla="*/ 0 w 541080"/>
                <a:gd name="textAreaRight" fmla="*/ 541440 w 5410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e46c0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Box 129"/>
            <p:cNvSpPr/>
            <p:nvPr/>
          </p:nvSpPr>
          <p:spPr>
            <a:xfrm>
              <a:off x="5340600" y="244332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E107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16"/>
            <p:cNvSpPr/>
            <p:nvPr/>
          </p:nvSpPr>
          <p:spPr>
            <a:xfrm>
              <a:off x="1011240" y="2014560"/>
              <a:ext cx="44053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447"/>
            <p:cNvSpPr/>
            <p:nvPr/>
          </p:nvSpPr>
          <p:spPr>
            <a:xfrm>
              <a:off x="1172880" y="1936800"/>
              <a:ext cx="336240" cy="145800"/>
            </a:xfrm>
            <a:custGeom>
              <a:avLst/>
              <a:gdLst>
                <a:gd name="textAreaLeft" fmla="*/ 0 w 336240"/>
                <a:gd name="textAreaRight" fmla="*/ 336600 w 3362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447"/>
            <p:cNvSpPr/>
            <p:nvPr/>
          </p:nvSpPr>
          <p:spPr>
            <a:xfrm>
              <a:off x="4692600" y="1938240"/>
              <a:ext cx="363240" cy="147600"/>
            </a:xfrm>
            <a:custGeom>
              <a:avLst/>
              <a:gdLst>
                <a:gd name="textAreaLeft" fmla="*/ 0 w 363240"/>
                <a:gd name="textAreaRight" fmla="*/ 363600 w 3632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Freeform 447"/>
            <p:cNvSpPr/>
            <p:nvPr/>
          </p:nvSpPr>
          <p:spPr>
            <a:xfrm>
              <a:off x="1496880" y="1938240"/>
              <a:ext cx="379080" cy="145800"/>
            </a:xfrm>
            <a:custGeom>
              <a:avLst/>
              <a:gdLst>
                <a:gd name="textAreaLeft" fmla="*/ 0 w 379080"/>
                <a:gd name="textAreaRight" fmla="*/ 379440 w 37908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Box 134"/>
            <p:cNvSpPr/>
            <p:nvPr/>
          </p:nvSpPr>
          <p:spPr>
            <a:xfrm>
              <a:off x="734400" y="2049120"/>
              <a:ext cx="83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FWG_0137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135"/>
            <p:cNvSpPr/>
            <p:nvPr/>
          </p:nvSpPr>
          <p:spPr>
            <a:xfrm>
              <a:off x="1441440" y="2049120"/>
              <a:ext cx="520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137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447"/>
            <p:cNvSpPr/>
            <p:nvPr/>
          </p:nvSpPr>
          <p:spPr>
            <a:xfrm>
              <a:off x="1915920" y="1940040"/>
              <a:ext cx="392040" cy="145800"/>
            </a:xfrm>
            <a:custGeom>
              <a:avLst/>
              <a:gdLst>
                <a:gd name="textAreaLeft" fmla="*/ 0 w 392040"/>
                <a:gd name="textAreaRight" fmla="*/ 392400 w 392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Box 137"/>
            <p:cNvSpPr/>
            <p:nvPr/>
          </p:nvSpPr>
          <p:spPr>
            <a:xfrm>
              <a:off x="1849680" y="2049120"/>
              <a:ext cx="520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137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447"/>
            <p:cNvSpPr/>
            <p:nvPr/>
          </p:nvSpPr>
          <p:spPr>
            <a:xfrm>
              <a:off x="2368440" y="1941480"/>
              <a:ext cx="393480" cy="147600"/>
            </a:xfrm>
            <a:custGeom>
              <a:avLst/>
              <a:gdLst>
                <a:gd name="textAreaLeft" fmla="*/ 0 w 393480"/>
                <a:gd name="textAreaRight" fmla="*/ 393480 w 3934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Box 139"/>
            <p:cNvSpPr/>
            <p:nvPr/>
          </p:nvSpPr>
          <p:spPr>
            <a:xfrm>
              <a:off x="2310120" y="2049120"/>
              <a:ext cx="47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13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Freeform 447"/>
            <p:cNvSpPr/>
            <p:nvPr/>
          </p:nvSpPr>
          <p:spPr>
            <a:xfrm>
              <a:off x="2747880" y="1943280"/>
              <a:ext cx="564840" cy="147600"/>
            </a:xfrm>
            <a:custGeom>
              <a:avLst/>
              <a:gdLst>
                <a:gd name="textAreaLeft" fmla="*/ 0 w 564840"/>
                <a:gd name="textAreaRight" fmla="*/ 565200 w 5648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Box 141"/>
            <p:cNvSpPr/>
            <p:nvPr/>
          </p:nvSpPr>
          <p:spPr>
            <a:xfrm>
              <a:off x="2746800" y="2049120"/>
              <a:ext cx="47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13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447"/>
            <p:cNvSpPr/>
            <p:nvPr/>
          </p:nvSpPr>
          <p:spPr>
            <a:xfrm>
              <a:off x="4105080" y="1940040"/>
              <a:ext cx="554040" cy="145800"/>
            </a:xfrm>
            <a:custGeom>
              <a:avLst/>
              <a:gdLst>
                <a:gd name="textAreaLeft" fmla="*/ 0 w 554040"/>
                <a:gd name="textAreaRight" fmla="*/ 554400 w 554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Freeform 447"/>
            <p:cNvSpPr/>
            <p:nvPr/>
          </p:nvSpPr>
          <p:spPr>
            <a:xfrm rot="10800000">
              <a:off x="3507480" y="1939680"/>
              <a:ext cx="91080" cy="146880"/>
            </a:xfrm>
            <a:custGeom>
              <a:avLst/>
              <a:gdLst>
                <a:gd name="textAreaLeft" fmla="*/ 0 w 91080"/>
                <a:gd name="textAreaRight" fmla="*/ 91440 w 9108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447"/>
            <p:cNvSpPr/>
            <p:nvPr/>
          </p:nvSpPr>
          <p:spPr>
            <a:xfrm rot="10800000">
              <a:off x="3680640" y="1936440"/>
              <a:ext cx="159840" cy="146880"/>
            </a:xfrm>
            <a:custGeom>
              <a:avLst/>
              <a:gdLst>
                <a:gd name="textAreaLeft" fmla="*/ 0 w 159840"/>
                <a:gd name="textAreaRight" fmla="*/ 160200 w 15984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447"/>
            <p:cNvSpPr/>
            <p:nvPr/>
          </p:nvSpPr>
          <p:spPr>
            <a:xfrm rot="10800000">
              <a:off x="3903120" y="1937880"/>
              <a:ext cx="159840" cy="146880"/>
            </a:xfrm>
            <a:custGeom>
              <a:avLst/>
              <a:gdLst>
                <a:gd name="textAreaLeft" fmla="*/ 0 w 159840"/>
                <a:gd name="textAreaRight" fmla="*/ 160200 w 15984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Box 146"/>
            <p:cNvSpPr/>
            <p:nvPr/>
          </p:nvSpPr>
          <p:spPr>
            <a:xfrm>
              <a:off x="3305160" y="2049120"/>
              <a:ext cx="47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137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Box 147"/>
            <p:cNvSpPr/>
            <p:nvPr/>
          </p:nvSpPr>
          <p:spPr>
            <a:xfrm>
              <a:off x="3553200" y="2145240"/>
              <a:ext cx="47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137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Box 148"/>
            <p:cNvSpPr/>
            <p:nvPr/>
          </p:nvSpPr>
          <p:spPr>
            <a:xfrm>
              <a:off x="3755520" y="2049120"/>
              <a:ext cx="47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137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Box 149"/>
            <p:cNvSpPr/>
            <p:nvPr/>
          </p:nvSpPr>
          <p:spPr>
            <a:xfrm>
              <a:off x="4129200" y="2049120"/>
              <a:ext cx="47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137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Box 150"/>
            <p:cNvSpPr/>
            <p:nvPr/>
          </p:nvSpPr>
          <p:spPr>
            <a:xfrm>
              <a:off x="4624560" y="2049120"/>
              <a:ext cx="47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13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Freeform 447"/>
            <p:cNvSpPr/>
            <p:nvPr/>
          </p:nvSpPr>
          <p:spPr>
            <a:xfrm>
              <a:off x="1174680" y="1746360"/>
              <a:ext cx="336240" cy="147600"/>
            </a:xfrm>
            <a:custGeom>
              <a:avLst/>
              <a:gdLst>
                <a:gd name="textAreaLeft" fmla="*/ 0 w 336240"/>
                <a:gd name="textAreaRight" fmla="*/ 336600 w 3362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Freeform 447"/>
            <p:cNvSpPr/>
            <p:nvPr/>
          </p:nvSpPr>
          <p:spPr>
            <a:xfrm>
              <a:off x="4694040" y="1749240"/>
              <a:ext cx="363240" cy="147600"/>
            </a:xfrm>
            <a:custGeom>
              <a:avLst/>
              <a:gdLst>
                <a:gd name="textAreaLeft" fmla="*/ 0 w 363240"/>
                <a:gd name="textAreaRight" fmla="*/ 363600 w 3632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Freeform 447"/>
            <p:cNvSpPr/>
            <p:nvPr/>
          </p:nvSpPr>
          <p:spPr>
            <a:xfrm>
              <a:off x="1498320" y="1749240"/>
              <a:ext cx="379080" cy="145800"/>
            </a:xfrm>
            <a:custGeom>
              <a:avLst/>
              <a:gdLst>
                <a:gd name="textAreaLeft" fmla="*/ 0 w 379080"/>
                <a:gd name="textAreaRight" fmla="*/ 379440 w 37908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Freeform 447"/>
            <p:cNvSpPr/>
            <p:nvPr/>
          </p:nvSpPr>
          <p:spPr>
            <a:xfrm>
              <a:off x="1917720" y="1751040"/>
              <a:ext cx="392040" cy="145800"/>
            </a:xfrm>
            <a:custGeom>
              <a:avLst/>
              <a:gdLst>
                <a:gd name="textAreaLeft" fmla="*/ 0 w 392040"/>
                <a:gd name="textAreaRight" fmla="*/ 392400 w 392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447"/>
            <p:cNvSpPr/>
            <p:nvPr/>
          </p:nvSpPr>
          <p:spPr>
            <a:xfrm>
              <a:off x="2371680" y="1752480"/>
              <a:ext cx="392040" cy="145800"/>
            </a:xfrm>
            <a:custGeom>
              <a:avLst/>
              <a:gdLst>
                <a:gd name="textAreaLeft" fmla="*/ 0 w 392040"/>
                <a:gd name="textAreaRight" fmla="*/ 392400 w 392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Freeform 447"/>
            <p:cNvSpPr/>
            <p:nvPr/>
          </p:nvSpPr>
          <p:spPr>
            <a:xfrm>
              <a:off x="2749320" y="1754280"/>
              <a:ext cx="564840" cy="145800"/>
            </a:xfrm>
            <a:custGeom>
              <a:avLst/>
              <a:gdLst>
                <a:gd name="textAreaLeft" fmla="*/ 0 w 564840"/>
                <a:gd name="textAreaRight" fmla="*/ 565200 w 5648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reeform 447"/>
            <p:cNvSpPr/>
            <p:nvPr/>
          </p:nvSpPr>
          <p:spPr>
            <a:xfrm>
              <a:off x="4106880" y="1751040"/>
              <a:ext cx="554040" cy="145800"/>
            </a:xfrm>
            <a:custGeom>
              <a:avLst/>
              <a:gdLst>
                <a:gd name="textAreaLeft" fmla="*/ 0 w 554040"/>
                <a:gd name="textAreaRight" fmla="*/ 554400 w 554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Freeform 447"/>
            <p:cNvSpPr/>
            <p:nvPr/>
          </p:nvSpPr>
          <p:spPr>
            <a:xfrm rot="10800000">
              <a:off x="3436560" y="1750320"/>
              <a:ext cx="164160" cy="146880"/>
            </a:xfrm>
            <a:custGeom>
              <a:avLst/>
              <a:gdLst>
                <a:gd name="textAreaLeft" fmla="*/ 0 w 164160"/>
                <a:gd name="textAreaRight" fmla="*/ 164520 w 16416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Freeform 447"/>
            <p:cNvSpPr/>
            <p:nvPr/>
          </p:nvSpPr>
          <p:spPr>
            <a:xfrm rot="10800000">
              <a:off x="3633840" y="1747080"/>
              <a:ext cx="208080" cy="146880"/>
            </a:xfrm>
            <a:custGeom>
              <a:avLst/>
              <a:gdLst>
                <a:gd name="textAreaLeft" fmla="*/ 0 w 208080"/>
                <a:gd name="textAreaRight" fmla="*/ 208080 w 20808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Freeform 447"/>
            <p:cNvSpPr/>
            <p:nvPr/>
          </p:nvSpPr>
          <p:spPr>
            <a:xfrm rot="10800000">
              <a:off x="3904920" y="1748880"/>
              <a:ext cx="159840" cy="146880"/>
            </a:xfrm>
            <a:custGeom>
              <a:avLst/>
              <a:gdLst>
                <a:gd name="textAreaLeft" fmla="*/ 0 w 159840"/>
                <a:gd name="textAreaRight" fmla="*/ 160200 w 15984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Freeform 447"/>
            <p:cNvSpPr/>
            <p:nvPr/>
          </p:nvSpPr>
          <p:spPr>
            <a:xfrm>
              <a:off x="1171440" y="1557360"/>
              <a:ext cx="336240" cy="147600"/>
            </a:xfrm>
            <a:custGeom>
              <a:avLst/>
              <a:gdLst>
                <a:gd name="textAreaLeft" fmla="*/ 0 w 336240"/>
                <a:gd name="textAreaRight" fmla="*/ 336600 w 3362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ccc1da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Freeform 447"/>
            <p:cNvSpPr/>
            <p:nvPr/>
          </p:nvSpPr>
          <p:spPr>
            <a:xfrm>
              <a:off x="4803840" y="1560600"/>
              <a:ext cx="365040" cy="145800"/>
            </a:xfrm>
            <a:custGeom>
              <a:avLst/>
              <a:gdLst>
                <a:gd name="textAreaLeft" fmla="*/ 0 w 365040"/>
                <a:gd name="textAreaRight" fmla="*/ 365400 w 3650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8eb4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Freeform 447"/>
            <p:cNvSpPr/>
            <p:nvPr/>
          </p:nvSpPr>
          <p:spPr>
            <a:xfrm>
              <a:off x="1495440" y="1558800"/>
              <a:ext cx="379080" cy="147600"/>
            </a:xfrm>
            <a:custGeom>
              <a:avLst/>
              <a:gdLst>
                <a:gd name="textAreaLeft" fmla="*/ 0 w 379080"/>
                <a:gd name="textAreaRight" fmla="*/ 379440 w 3790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Freeform 447"/>
            <p:cNvSpPr/>
            <p:nvPr/>
          </p:nvSpPr>
          <p:spPr>
            <a:xfrm>
              <a:off x="1914480" y="1560600"/>
              <a:ext cx="392040" cy="147600"/>
            </a:xfrm>
            <a:custGeom>
              <a:avLst/>
              <a:gdLst>
                <a:gd name="textAreaLeft" fmla="*/ 0 w 392040"/>
                <a:gd name="textAreaRight" fmla="*/ 392400 w 39204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447"/>
            <p:cNvSpPr/>
            <p:nvPr/>
          </p:nvSpPr>
          <p:spPr>
            <a:xfrm>
              <a:off x="2367000" y="1562040"/>
              <a:ext cx="393480" cy="147600"/>
            </a:xfrm>
            <a:custGeom>
              <a:avLst/>
              <a:gdLst>
                <a:gd name="textAreaLeft" fmla="*/ 0 w 393480"/>
                <a:gd name="textAreaRight" fmla="*/ 393480 w 393480"/>
                <a:gd name="textAreaTop" fmla="*/ 0 h 147600"/>
                <a:gd name="textAreaBottom" fmla="*/ 147960 h 1476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Freeform 447"/>
            <p:cNvSpPr/>
            <p:nvPr/>
          </p:nvSpPr>
          <p:spPr>
            <a:xfrm>
              <a:off x="2746080" y="1565280"/>
              <a:ext cx="564840" cy="145800"/>
            </a:xfrm>
            <a:custGeom>
              <a:avLst/>
              <a:gdLst>
                <a:gd name="textAreaLeft" fmla="*/ 0 w 564840"/>
                <a:gd name="textAreaRight" fmla="*/ 565200 w 564840"/>
                <a:gd name="textAreaTop" fmla="*/ 0 h 145800"/>
                <a:gd name="textAreaBottom" fmla="*/ 146160 h 14580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77933c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 447"/>
            <p:cNvSpPr/>
            <p:nvPr/>
          </p:nvSpPr>
          <p:spPr>
            <a:xfrm rot="10800000">
              <a:off x="3506040" y="1560960"/>
              <a:ext cx="91080" cy="146880"/>
            </a:xfrm>
            <a:custGeom>
              <a:avLst/>
              <a:gdLst>
                <a:gd name="textAreaLeft" fmla="*/ 0 w 91080"/>
                <a:gd name="textAreaRight" fmla="*/ 91440 w 9108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Freeform 447"/>
            <p:cNvSpPr/>
            <p:nvPr/>
          </p:nvSpPr>
          <p:spPr>
            <a:xfrm rot="10800000">
              <a:off x="3678840" y="1557720"/>
              <a:ext cx="81360" cy="146880"/>
            </a:xfrm>
            <a:custGeom>
              <a:avLst/>
              <a:gdLst>
                <a:gd name="textAreaLeft" fmla="*/ 0 w 81360"/>
                <a:gd name="textAreaRight" fmla="*/ 81720 w 8136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 447"/>
            <p:cNvSpPr/>
            <p:nvPr/>
          </p:nvSpPr>
          <p:spPr>
            <a:xfrm rot="10800000">
              <a:off x="3901680" y="1559520"/>
              <a:ext cx="159840" cy="146880"/>
            </a:xfrm>
            <a:custGeom>
              <a:avLst/>
              <a:gdLst>
                <a:gd name="textAreaLeft" fmla="*/ 0 w 159840"/>
                <a:gd name="textAreaRight" fmla="*/ 160200 w 15984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TextBox 171"/>
            <p:cNvSpPr/>
            <p:nvPr/>
          </p:nvSpPr>
          <p:spPr>
            <a:xfrm>
              <a:off x="5356440" y="1877400"/>
              <a:ext cx="928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ff0000"/>
                  </a:solidFill>
                  <a:latin typeface="Calibri"/>
                </a:rPr>
                <a:t>Com1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; E167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TextBox 172"/>
            <p:cNvSpPr/>
            <p:nvPr/>
          </p:nvSpPr>
          <p:spPr>
            <a:xfrm>
              <a:off x="5337360" y="170280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E163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TextBox 173"/>
            <p:cNvSpPr/>
            <p:nvPr/>
          </p:nvSpPr>
          <p:spPr>
            <a:xfrm>
              <a:off x="5339160" y="1501920"/>
              <a:ext cx="49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E103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Freeform 447"/>
            <p:cNvSpPr/>
            <p:nvPr/>
          </p:nvSpPr>
          <p:spPr>
            <a:xfrm>
              <a:off x="4084920" y="1560240"/>
              <a:ext cx="189000" cy="146880"/>
            </a:xfrm>
            <a:custGeom>
              <a:avLst/>
              <a:gdLst>
                <a:gd name="textAreaLeft" fmla="*/ 0 w 189000"/>
                <a:gd name="textAreaRight" fmla="*/ 189360 w 18900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b0f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Freeform 447"/>
            <p:cNvSpPr/>
            <p:nvPr/>
          </p:nvSpPr>
          <p:spPr>
            <a:xfrm>
              <a:off x="4285440" y="1562760"/>
              <a:ext cx="502920" cy="146880"/>
            </a:xfrm>
            <a:custGeom>
              <a:avLst/>
              <a:gdLst>
                <a:gd name="textAreaLeft" fmla="*/ 0 w 502920"/>
                <a:gd name="textAreaRight" fmla="*/ 503280 w 502920"/>
                <a:gd name="textAreaTop" fmla="*/ 0 h 146880"/>
                <a:gd name="textAreaBottom" fmla="*/ 147240 h 146880"/>
              </a:gdLst>
              <a:ahLst/>
              <a:rect l="textAreaLeft" t="textAreaTop" r="textAreaRight" b="textAreaBottom"/>
              <a:pathLst>
                <a:path w="545" h="128">
                  <a:moveTo>
                    <a:pt x="432" y="106"/>
                  </a:moveTo>
                  <a:lnTo>
                    <a:pt x="0" y="106"/>
                  </a:lnTo>
                  <a:lnTo>
                    <a:pt x="0" y="22"/>
                  </a:lnTo>
                  <a:lnTo>
                    <a:pt x="432" y="22"/>
                  </a:lnTo>
                  <a:lnTo>
                    <a:pt x="432" y="0"/>
                  </a:lnTo>
                  <a:lnTo>
                    <a:pt x="545" y="64"/>
                  </a:lnTo>
                  <a:lnTo>
                    <a:pt x="432" y="128"/>
                  </a:lnTo>
                  <a:lnTo>
                    <a:pt x="432" y="106"/>
                  </a:lnTo>
                  <a:close/>
                </a:path>
              </a:pathLst>
            </a:custGeom>
            <a:solidFill>
              <a:srgbClr val="00b0f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8" name="TextBox 181"/>
          <p:cNvSpPr/>
          <p:nvPr/>
        </p:nvSpPr>
        <p:spPr>
          <a:xfrm>
            <a:off x="420840" y="4835520"/>
            <a:ext cx="80737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- ORF composition of the downstream extension of the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p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cluster in the 22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 faecium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omes (HMPREF0351_10908 - HMPREF0351_10923 in TX16)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predicted polysaccharide-encoding gene clusters can be divided into four main groups (Locus 1-4) based on sequence similarities; shades of the same color indicate similar sequences. Vertical lines connect orthologs of different groups. Letters A and B indicate orthologs of HMPREF0351_10908 and HMPREF02513_02513, respectively. Gene locus tags of each group are based on the respective strain in bold (Locus 1, Com15; Locus 2, TX1330; Locus 3, TX82; Locus 4, TX16).  CA -clade strains are indicated by red fon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Box 48"/>
          <p:cNvSpPr/>
          <p:nvPr/>
        </p:nvSpPr>
        <p:spPr>
          <a:xfrm>
            <a:off x="300960" y="16444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183"/>
          <p:cNvSpPr/>
          <p:nvPr/>
        </p:nvSpPr>
        <p:spPr>
          <a:xfrm>
            <a:off x="306000" y="26924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Box 184"/>
          <p:cNvSpPr/>
          <p:nvPr/>
        </p:nvSpPr>
        <p:spPr>
          <a:xfrm>
            <a:off x="298080" y="35434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185"/>
          <p:cNvSpPr/>
          <p:nvPr/>
        </p:nvSpPr>
        <p:spPr>
          <a:xfrm>
            <a:off x="291600" y="39718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Straight Connector 176"/>
          <p:cNvSpPr/>
          <p:nvPr/>
        </p:nvSpPr>
        <p:spPr>
          <a:xfrm>
            <a:off x="5262480" y="3787920"/>
            <a:ext cx="1616040" cy="231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Straight Connector 179"/>
          <p:cNvSpPr/>
          <p:nvPr/>
        </p:nvSpPr>
        <p:spPr>
          <a:xfrm>
            <a:off x="5042880" y="3352680"/>
            <a:ext cx="14040" cy="225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Straight Connector 186"/>
          <p:cNvSpPr/>
          <p:nvPr/>
        </p:nvSpPr>
        <p:spPr>
          <a:xfrm>
            <a:off x="4863240" y="2265480"/>
            <a:ext cx="112680" cy="231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Straight Connector 194"/>
          <p:cNvSpPr/>
          <p:nvPr/>
        </p:nvSpPr>
        <p:spPr>
          <a:xfrm flipH="1">
            <a:off x="1709280" y="3313080"/>
            <a:ext cx="3240" cy="27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Straight Connector 196"/>
          <p:cNvSpPr/>
          <p:nvPr/>
        </p:nvSpPr>
        <p:spPr>
          <a:xfrm flipH="1">
            <a:off x="2035080" y="3352680"/>
            <a:ext cx="44640" cy="225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Straight Connector 200"/>
          <p:cNvSpPr/>
          <p:nvPr/>
        </p:nvSpPr>
        <p:spPr>
          <a:xfrm flipH="1">
            <a:off x="2322360" y="3352680"/>
            <a:ext cx="44640" cy="233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Straight Connector 203"/>
          <p:cNvSpPr/>
          <p:nvPr/>
        </p:nvSpPr>
        <p:spPr>
          <a:xfrm flipH="1">
            <a:off x="2681280" y="3354480"/>
            <a:ext cx="46080" cy="233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Straight Connector 204"/>
          <p:cNvSpPr/>
          <p:nvPr/>
        </p:nvSpPr>
        <p:spPr>
          <a:xfrm>
            <a:off x="2902680" y="3348000"/>
            <a:ext cx="101880" cy="222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Box 206"/>
          <p:cNvSpPr/>
          <p:nvPr/>
        </p:nvSpPr>
        <p:spPr>
          <a:xfrm>
            <a:off x="1274040" y="4532400"/>
            <a:ext cx="2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Box 207"/>
          <p:cNvSpPr/>
          <p:nvPr/>
        </p:nvSpPr>
        <p:spPr>
          <a:xfrm>
            <a:off x="1220040" y="4008600"/>
            <a:ext cx="25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Box 211"/>
          <p:cNvSpPr/>
          <p:nvPr/>
        </p:nvSpPr>
        <p:spPr>
          <a:xfrm>
            <a:off x="1195920" y="3579840"/>
            <a:ext cx="2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4" name="Group 181"/>
          <p:cNvGrpSpPr/>
          <p:nvPr/>
        </p:nvGrpSpPr>
        <p:grpSpPr>
          <a:xfrm>
            <a:off x="1221840" y="2470320"/>
            <a:ext cx="267120" cy="760680"/>
            <a:chOff x="1221840" y="2470320"/>
            <a:chExt cx="267120" cy="760680"/>
          </a:xfrm>
        </p:grpSpPr>
        <p:sp>
          <p:nvSpPr>
            <p:cNvPr id="215" name="TextBox 208"/>
            <p:cNvSpPr/>
            <p:nvPr/>
          </p:nvSpPr>
          <p:spPr>
            <a:xfrm>
              <a:off x="1221840" y="2984760"/>
              <a:ext cx="25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TextBox 209"/>
            <p:cNvSpPr/>
            <p:nvPr/>
          </p:nvSpPr>
          <p:spPr>
            <a:xfrm>
              <a:off x="1231200" y="2819520"/>
              <a:ext cx="25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TextBox 210"/>
            <p:cNvSpPr/>
            <p:nvPr/>
          </p:nvSpPr>
          <p:spPr>
            <a:xfrm>
              <a:off x="1231920" y="2470320"/>
              <a:ext cx="25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Box 212"/>
            <p:cNvSpPr/>
            <p:nvPr/>
          </p:nvSpPr>
          <p:spPr>
            <a:xfrm>
              <a:off x="1229760" y="265104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9" name="TextBox 213"/>
          <p:cNvSpPr/>
          <p:nvPr/>
        </p:nvSpPr>
        <p:spPr>
          <a:xfrm>
            <a:off x="1199160" y="1889280"/>
            <a:ext cx="2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214"/>
          <p:cNvSpPr/>
          <p:nvPr/>
        </p:nvSpPr>
        <p:spPr>
          <a:xfrm>
            <a:off x="1207800" y="1698480"/>
            <a:ext cx="2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215"/>
          <p:cNvSpPr/>
          <p:nvPr/>
        </p:nvSpPr>
        <p:spPr>
          <a:xfrm>
            <a:off x="1217520" y="1509840"/>
            <a:ext cx="25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09T21:03:24Z</dcterms:created>
  <dc:creator>jgallowaypena</dc:creator>
  <dc:description/>
  <dc:language>en-US</dc:language>
  <cp:lastModifiedBy>jgallowaypena</cp:lastModifiedBy>
  <dcterms:modified xsi:type="dcterms:W3CDTF">2012-05-10T20:44:00Z</dcterms:modified>
  <cp:revision>3</cp:revision>
  <dc:subject/>
  <dc:title>Slide 1</dc:title>
</cp:coreProperties>
</file>